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1FECB4D8-DB02-4DC6-A0A2-4F2EBAE1DC90}" styleName="中間スタイル 1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48"/>
    <p:restoredTop sz="96327"/>
  </p:normalViewPr>
  <p:slideViewPr>
    <p:cSldViewPr snapToGrid="0">
      <p:cViewPr varScale="1">
        <p:scale>
          <a:sx n="128" d="100"/>
          <a:sy n="128" d="100"/>
        </p:scale>
        <p:origin x="2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36F136-6D1A-22F4-54F9-251B3C17CB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8055CA9-92A9-7B5E-34BC-3989F062A9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A19C0D-25A9-A297-F67F-C1494F4D2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E87D10-FFC8-59B7-9D51-61B578267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02A607-35D5-2D48-75FF-74ECB3ED6A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9997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B26364-B68D-FCD5-7F93-D50A407BC5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7171425-1434-2035-DDC4-1CC58701DB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7D4A9E-34F9-D609-AFA6-9A8C40BB7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E830CAC-C78D-2E08-1D35-782E8F880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46BB0B9-1144-299C-26FE-C324B5FB4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8289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3328F34-5ECB-132F-33F4-F538D24330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B5E2F72-C9E7-4C3D-CCEB-E9824037FA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58AB107-598A-2CBE-64EE-5AEEE67B3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00A6AE-763D-95A8-A2C4-D0AE4FCE44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28E38A-9CD3-759D-0519-632018DB9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42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1D52B6-7F14-92BA-98A1-F5EBE8BB28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A5B4499-1C26-5267-8234-480AA16896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8EA0ED7-39A2-A43A-410F-8D3CE26F4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0FBB07-3624-1DE3-9944-2C18259DA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8B2C524-7394-006C-22C2-7416025E2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482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48C0D7-D208-EC5C-EE37-E27F0E15E2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A76A718-C3EF-819D-C1B0-8B6036F0B1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A8EAA4-27EF-DA32-5156-1640E9B4E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08AAFF-7574-64BC-01A1-AD3949197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F3AFFC-3DEE-9138-9798-79C94B5C2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5370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AA7F0F-5639-2F94-3C9F-F159325706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6BC7D13-EBA2-0549-B099-347EA568B3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D1CAC81-7092-31A2-1F4C-69B1E9F733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ACF173-837E-7965-FDFE-62B315411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5BF292D-5917-22E8-8BA2-80351717DD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928A8EC-78BA-1513-E0E7-2B60064B9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781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D7F395-8082-3781-BC33-372F687EC0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B0D6B16-16AF-77A2-6270-913AA08818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6C73365-4026-C4D1-E1BB-7848FE49AC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D0D2D69-0749-85BA-3802-32364AFC35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AF67806-5E38-D887-7419-8C14275842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5EF6987-4D9B-406C-7B52-1CE6E20A17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FD3E176-3BE2-2930-E314-9BBEBDDBA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FB25EE6-0993-DAC0-9C2D-57ACD3C76D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2667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A8CF5D-CF0C-F297-DB5E-2AA87C6711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D2FEB10-02FA-0C8A-205C-9C3A6B4B5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F4A9FBA-B8BA-76A3-4563-3EC477D30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21533DA-F194-9E1B-2FCC-C4F393F2EB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6306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D70B331-3157-D570-9BF4-0D071156D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EC01ADD-DCF4-6768-CB59-6B156E72A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128BA38-2D86-8133-3063-FFF306E83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976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D74932-6AB2-91BF-84FE-444DA0D7ED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1E0F9EF-A078-895D-DBBD-0F840EFE52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C3D0B94-EE81-8DB7-CBB9-B05BE58AD0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05D8857-7189-D227-61FE-F3A4328DB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2523F7-6394-0B73-C801-263EDA174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0FB2513-84A6-FA41-FAA7-68EF453E7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6959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442CA1-BBF7-5499-E7FA-33BB44C01F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5DA0F2E-CE5F-A3C4-AB22-2AD3DA542D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19833BC-8C9B-3AE2-06EC-9009F7AAEB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657786-8983-7221-314F-48C9A1B76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AB977A7-AC9D-7580-C6D7-0C6786D3C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8D0BB81-DA15-32BA-EB49-CB2D1AACB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3575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1940E18-12BE-16DA-C109-1D0D83446F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3A5DC55-94C8-8842-C078-8E76C72DBC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B3CC18-E4AB-C624-1ED3-389FEE54CC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24691-D68C-E94C-BB6F-FB64B39FCF0D}" type="datetimeFigureOut">
              <a:rPr kumimoji="1" lang="ja-JP" altLang="en-US" smtClean="0"/>
              <a:t>2024/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8337C6-60EF-5D10-E39B-287195F46D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F3A1BE-49DB-C36E-7D36-9B926C1132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5536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50C0B37-8292-EE33-1D3C-8B69D146C6FF}"/>
              </a:ext>
            </a:extLst>
          </p:cNvPr>
          <p:cNvSpPr txBox="1"/>
          <p:nvPr/>
        </p:nvSpPr>
        <p:spPr>
          <a:xfrm>
            <a:off x="163643" y="1067151"/>
            <a:ext cx="6675336" cy="5509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MBOAT1     membrane bound O-acyltransferase domain containing1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ZMYND8     zinc finger and  MYND-type containing 38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CD28           CD28 molecule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CC2            regulator of chromosome condensation 2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CABLES1     </a:t>
            </a:r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Cdk5 and </a:t>
            </a:r>
            <a:r>
              <a:rPr lang="en-US" altLang="ja-JP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Abl</a:t>
            </a:r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 enzyme substrate 1</a:t>
            </a:r>
            <a:endParaRPr kumimoji="1" lang="en-US" altLang="ja-JP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MYC             v-</a:t>
            </a:r>
            <a:r>
              <a:rPr lang="en-US" altLang="ja-JP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myc</a:t>
            </a:r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 avian </a:t>
            </a:r>
            <a:r>
              <a:rPr lang="en-US" altLang="ja-JP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myelocytomatosis</a:t>
            </a:r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 viral oncogene homolog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ANP32A      acidic nuclear phosphoprotein 32 family member A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CUL1           cullin1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CC              regulator of chromosome condensation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LY96             lymphocyte antigen 96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HMGB1       high mobility group box 1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IFI16            interferon gamma-inducible protein 16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SCL38A1     solute carrier family member 1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ANP32B8    acidic nuclear phosphoprotein 32 family member B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PRDM1       PR domain containing 1 with ZNF domain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CFLAR         CASP8 and FDAA like apoptosis regulator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ZBTB38       zinc finger and BTB domain containing 38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DDX17        DEAD(Asp-Glu-Ala-Asp) box helicase 17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ATIC             5-aminounucazile-4-carboxamide ribonucleotide </a:t>
            </a:r>
            <a:r>
              <a:rPr kumimoji="1" lang="en-US" altLang="ja-JP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formyltransferase</a:t>
            </a:r>
            <a:endParaRPr kumimoji="1" lang="en-US" altLang="ja-JP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HMGB1P5. high mobility group box 1 pseudogene 5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GMFG         Glia maturation factor gamma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PIM2           Pim-2 proto-oncogene serine/threonine kinase</a:t>
            </a:r>
            <a:endParaRPr kumimoji="1" lang="ja-JP" altLang="en-US" sz="16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2DB412EF-4818-1C3B-D431-CAF258011BAD}"/>
              </a:ext>
            </a:extLst>
          </p:cNvPr>
          <p:cNvCxnSpPr/>
          <p:nvPr/>
        </p:nvCxnSpPr>
        <p:spPr>
          <a:xfrm>
            <a:off x="1139110" y="1067151"/>
            <a:ext cx="0" cy="5509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78B6C57-6B8B-F068-AD4B-3058CD2B2A82}"/>
              </a:ext>
            </a:extLst>
          </p:cNvPr>
          <p:cNvSpPr txBox="1"/>
          <p:nvPr/>
        </p:nvSpPr>
        <p:spPr>
          <a:xfrm>
            <a:off x="7086114" y="1098312"/>
            <a:ext cx="4948969" cy="32932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NVU1-18     RNA, variant U1 small nuclear 18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NU1-28P     RNA, U1 small nuclear 28 pseudogene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NVU1-18     RNA, variant U1 small nuclear 18   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NU1-3          RNA, u1 small nuclear 3  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NVU1-18     RNA, variant Us small nuclear 18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NU1-4          RNA, U1 small nuclear 4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NU1-2          RNA, U1 small nuclear 2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NVU1-18     RNA, variant U1 small nuclear 18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NU1-27P     RNA, U1 small nuclear 27, pseudogene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NU1-89P     RNA, U1 small nuclear 89, pseudogene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NVU1-7       RNA, variant U1 small nuclear 7</a:t>
            </a: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U1                   U1 </a:t>
            </a:r>
            <a:r>
              <a:rPr lang="en-US" altLang="ja-JP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spliceosomal</a:t>
            </a:r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 RNA</a:t>
            </a:r>
            <a:endParaRPr kumimoji="1" lang="en-US" altLang="ja-JP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RNVU-14       RNA, variant U1 small nuclear 14</a:t>
            </a:r>
            <a:endParaRPr kumimoji="1" lang="ja-JP" altLang="en-US" sz="16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D8FBB15A-A74B-A8CD-2B83-E89C5F23667F}"/>
              </a:ext>
            </a:extLst>
          </p:cNvPr>
          <p:cNvCxnSpPr>
            <a:cxnSpLocks/>
          </p:cNvCxnSpPr>
          <p:nvPr/>
        </p:nvCxnSpPr>
        <p:spPr>
          <a:xfrm>
            <a:off x="8186580" y="1098312"/>
            <a:ext cx="0" cy="329320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180F451-917E-85D4-A664-BBD0CDE09F8A}"/>
              </a:ext>
            </a:extLst>
          </p:cNvPr>
          <p:cNvSpPr txBox="1"/>
          <p:nvPr/>
        </p:nvSpPr>
        <p:spPr>
          <a:xfrm>
            <a:off x="2190311" y="697819"/>
            <a:ext cx="2622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Down-regulated 23 genes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20385C4-8E62-A7E1-9512-7907C2A8CBCD}"/>
              </a:ext>
            </a:extLst>
          </p:cNvPr>
          <p:cNvSpPr txBox="1"/>
          <p:nvPr/>
        </p:nvSpPr>
        <p:spPr>
          <a:xfrm>
            <a:off x="8405442" y="697819"/>
            <a:ext cx="2310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Up-regulated 14 genes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EFF9F97-8AE2-9C11-40A2-C1546CA58F07}"/>
              </a:ext>
            </a:extLst>
          </p:cNvPr>
          <p:cNvSpPr txBox="1"/>
          <p:nvPr/>
        </p:nvSpPr>
        <p:spPr>
          <a:xfrm>
            <a:off x="476099" y="113235"/>
            <a:ext cx="107650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</a:t>
            </a:r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T</a:t>
            </a:r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able S3. </a:t>
            </a:r>
            <a:r>
              <a:rPr kumimoji="1" lang="es-E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G</a:t>
            </a:r>
            <a:r>
              <a:rPr lang="en-US" altLang="ja-JP" sz="1800" b="1" dirty="0" err="1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ene</a:t>
            </a:r>
            <a:r>
              <a:rPr lang="en-US" altLang="ja-JP" sz="1800" b="1" dirty="0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 descriptions in myeloma cells, following treatment with </a:t>
            </a:r>
            <a:r>
              <a:rPr lang="en-US" altLang="ja-JP" sz="1800" b="1" dirty="0" err="1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panobinostat</a:t>
            </a:r>
            <a:r>
              <a:rPr lang="en-US" altLang="ja-JP" sz="1800" b="1" dirty="0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 or RG2833 using whole transcriptomic profiles.</a:t>
            </a:r>
            <a:endParaRPr lang="ja-JP" altLang="ja-JP" sz="1800" b="1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80120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263</Words>
  <Application>Microsoft Macintosh PowerPoint</Application>
  <PresentationFormat>ワイド画面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 </dc:creator>
  <cp:lastModifiedBy> </cp:lastModifiedBy>
  <cp:revision>12</cp:revision>
  <dcterms:created xsi:type="dcterms:W3CDTF">2024-01-06T05:47:42Z</dcterms:created>
  <dcterms:modified xsi:type="dcterms:W3CDTF">2024-01-20T07:32:13Z</dcterms:modified>
</cp:coreProperties>
</file>